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5" autoAdjust="0"/>
    <p:restoredTop sz="94660"/>
  </p:normalViewPr>
  <p:slideViewPr>
    <p:cSldViewPr snapToGrid="0">
      <p:cViewPr varScale="1">
        <p:scale>
          <a:sx n="81" d="100"/>
          <a:sy n="81" d="100"/>
        </p:scale>
        <p:origin x="202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186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354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572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789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88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112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33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784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640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64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252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B8A63E-DE3B-4F84-A878-202D27981FF8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B7689-77D4-453F-96E2-5FFF22CBCC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977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391" y="46306"/>
            <a:ext cx="1662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. Figure 1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165" y="499180"/>
            <a:ext cx="1844040" cy="1758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3805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1662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. Figure 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1779"/>
            <a:ext cx="6858000" cy="9696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5745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4666"/>
            <a:ext cx="6858000" cy="969684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1662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. Figur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1896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391" y="0"/>
            <a:ext cx="1662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. Figure 4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82" y="405427"/>
            <a:ext cx="6858000" cy="9696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8025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391" y="46306"/>
            <a:ext cx="1662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. Figure 5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1" y="525533"/>
            <a:ext cx="6858000" cy="96886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2904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662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. Figure 6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52306"/>
            <a:ext cx="6858000" cy="9696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839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4</Words>
  <Application>Microsoft Office PowerPoint</Application>
  <PresentationFormat>A4 Paper (210x297 mm)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shing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, Jiang</dc:creator>
  <cp:lastModifiedBy>Zhu, Jiang</cp:lastModifiedBy>
  <cp:revision>1</cp:revision>
  <dcterms:created xsi:type="dcterms:W3CDTF">2021-07-12T19:56:31Z</dcterms:created>
  <dcterms:modified xsi:type="dcterms:W3CDTF">2021-07-12T19:57:56Z</dcterms:modified>
</cp:coreProperties>
</file>